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75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napToGrid="0">
      <p:cViewPr varScale="1">
        <p:scale>
          <a:sx n="108" d="100"/>
          <a:sy n="108" d="100"/>
        </p:scale>
        <p:origin x="-108" y="-192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32CD732E-078B-4DC2-94E5-9F474BFCDA6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xmlns="" id="{1CE9DD8E-5B82-41D8-B4DB-7F77A28B51FA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0F23EA4D-55F0-4160-98AB-6C265846FA5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28C83F-BF15-4054-BA85-497E3547C9AD}" type="datetimeFigureOut">
              <a:rPr lang="en-GB" smtClean="0"/>
              <a:t>27/05/2019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A2FA1FF9-B94F-4DA8-9FDF-64A22172349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D1CEB9FE-2357-4BAF-9460-CAA0728E81C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95A5AF-13D4-49FB-BD28-1E6CFDBBF3D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8055912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A9256456-2657-4EDE-B1D0-012251E4117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xmlns="" id="{DE553D22-DE62-43AF-A69C-EECFD60DB18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A9F19EC4-1A8C-47FA-8DC1-F28283DAA0F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28C83F-BF15-4054-BA85-497E3547C9AD}" type="datetimeFigureOut">
              <a:rPr lang="en-GB" smtClean="0"/>
              <a:t>27/05/2019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5417BE30-52C8-4E99-9F7F-3037AB6561F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2102DC3F-D32F-4902-8BB9-8D40269F3AF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95A5AF-13D4-49FB-BD28-1E6CFDBBF3D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2538739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xmlns="" id="{A9681C43-1CFF-4095-BE9D-709D2BC81B03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899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xmlns="" id="{5A7F8F3B-9DED-4ED6-9407-241F17D98BD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199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71CBBC29-ED4E-4251-AF31-D2790192501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28C83F-BF15-4054-BA85-497E3547C9AD}" type="datetimeFigureOut">
              <a:rPr lang="en-GB" smtClean="0"/>
              <a:t>27/05/2019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AF198BF5-28B9-46FD-954F-B5BD4D88124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B9E6A2F2-F3EE-4B4F-A530-98AEEC57953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95A5AF-13D4-49FB-BD28-1E6CFDBBF3D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6851306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7C88948C-7B7E-48BC-A783-D03BB4B52C9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xmlns="" id="{7168F7F5-2A3C-4F59-B200-0A75D9C8762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C623E1D2-5404-40EE-983D-54416792008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28C83F-BF15-4054-BA85-497E3547C9AD}" type="datetimeFigureOut">
              <a:rPr lang="en-GB" smtClean="0"/>
              <a:t>27/05/2019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C75FD79C-C868-4010-B1E4-D780D4DBAA4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BFDA0D90-4225-4C1A-9B28-689207962AA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95A5AF-13D4-49FB-BD28-1E6CFDBBF3D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1006505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1A79728F-A017-48BA-AB32-628C2775B40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3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xmlns="" id="{8DEF846A-E3A5-49BD-A3BB-0666C112FFE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3" y="4589465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8521DD45-F097-4F8E-A927-1E101D7BBB7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28C83F-BF15-4054-BA85-497E3547C9AD}" type="datetimeFigureOut">
              <a:rPr lang="en-GB" smtClean="0"/>
              <a:t>27/05/2019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6BE74D55-A943-4931-A729-900B5A7669D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8B43EBD7-FA94-4EE6-9E52-7B846EC6B66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95A5AF-13D4-49FB-BD28-1E6CFDBBF3D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2933667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AE266206-043F-4783-B914-AF584899A26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xmlns="" id="{DECE2B5C-B8AF-4865-9C2E-91719B19003D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1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xmlns="" id="{4080E91D-7F9E-4B12-B211-CDD29E882CD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1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xmlns="" id="{73B32E6E-DB5C-416E-A90E-E1F3FE18954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28C83F-BF15-4054-BA85-497E3547C9AD}" type="datetimeFigureOut">
              <a:rPr lang="en-GB" smtClean="0"/>
              <a:t>27/05/2019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xmlns="" id="{4B6A23F5-A03B-4FC1-917F-088458DEAA8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xmlns="" id="{6701B811-2B75-4CB2-AFE6-AAA1D6215F7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95A5AF-13D4-49FB-BD28-1E6CFDBBF3D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5256722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026748B9-0945-4C9C-9578-22AA973C870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9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xmlns="" id="{4334971D-90B3-40C2-AA0C-F2F4B8C72F8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91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xmlns="" id="{BCF42C9E-992F-475D-A517-82505725931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91" y="2505076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xmlns="" id="{DF1FFA8C-F6B7-4FEA-BEAA-5CCEEDD1DE0F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3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xmlns="" id="{8A4C68FD-A37A-49B0-94B7-85E7AA669D6E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3" y="2505076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xmlns="" id="{6135BDE1-E441-46F4-A322-75D5E3C90FD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28C83F-BF15-4054-BA85-497E3547C9AD}" type="datetimeFigureOut">
              <a:rPr lang="en-GB" smtClean="0"/>
              <a:t>27/05/2019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xmlns="" id="{68C6777B-80FE-4564-97DC-D6E07BFF366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xmlns="" id="{67C8F08A-2C02-43F2-83F5-EC0838526A9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95A5AF-13D4-49FB-BD28-1E6CFDBBF3D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19033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1861D180-5A05-4FC5-B954-42FC4CE2650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xmlns="" id="{2CE1E76D-4AF9-40E0-AD9B-F9B27C7A70B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28C83F-BF15-4054-BA85-497E3547C9AD}" type="datetimeFigureOut">
              <a:rPr lang="en-GB" smtClean="0"/>
              <a:t>27/05/2019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xmlns="" id="{26D25075-4245-4AC2-A969-B13DA26541E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xmlns="" id="{9635C59E-EE60-4BDF-8620-5053F755DE5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95A5AF-13D4-49FB-BD28-1E6CFDBBF3D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6519239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xmlns="" id="{672851F4-5902-4B85-93E3-2BC763FF3E4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28C83F-BF15-4054-BA85-497E3547C9AD}" type="datetimeFigureOut">
              <a:rPr lang="en-GB" smtClean="0"/>
              <a:t>27/05/2019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xmlns="" id="{3B4C8EE9-CCE3-4B7D-A6F2-AB5FF237038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xmlns="" id="{10A1CA0F-E8CD-49C6-915F-8876FDF0F5D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95A5AF-13D4-49FB-BD28-1E6CFDBBF3D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3259673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08C60212-0517-480E-954E-4B2F3614A2B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91" y="457200"/>
            <a:ext cx="3932236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xmlns="" id="{45347984-7901-46C8-BF0A-6C8872BA234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90" y="987425"/>
            <a:ext cx="6172201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xmlns="" id="{15935EAB-BF7A-43F7-80A8-ABE6547E603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91" y="2057400"/>
            <a:ext cx="3932236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xmlns="" id="{9D647764-2860-42D6-81B3-B8C300F2C34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28C83F-BF15-4054-BA85-497E3547C9AD}" type="datetimeFigureOut">
              <a:rPr lang="en-GB" smtClean="0"/>
              <a:t>27/05/2019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xmlns="" id="{25F9D9E6-F750-4A5C-8938-713354DAF17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xmlns="" id="{1D6C39D6-07C2-4BA7-866F-9007E60CEE7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95A5AF-13D4-49FB-BD28-1E6CFDBBF3D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5356734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A03A3A31-268D-4E03-8C43-20DC637ED33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91" y="457200"/>
            <a:ext cx="3932236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xmlns="" id="{B133A85A-EB12-44EB-AAA0-CDF627B48B80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90" y="987425"/>
            <a:ext cx="6172201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xmlns="" id="{2B31086B-AF46-4160-9567-65422BF2387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91" y="2057400"/>
            <a:ext cx="3932236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xmlns="" id="{B668D097-11FD-41D1-8BA2-288AD428197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28C83F-BF15-4054-BA85-497E3547C9AD}" type="datetimeFigureOut">
              <a:rPr lang="en-GB" smtClean="0"/>
              <a:t>27/05/2019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xmlns="" id="{6374AC86-C6C9-4A3A-9373-93A1BC73158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xmlns="" id="{16370E70-17F3-4973-B29C-614F573C5CE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95A5AF-13D4-49FB-BD28-1E6CFDBBF3D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7470403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xmlns="" id="{B870B31C-9F19-45FB-894A-E70BD3EE2C1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4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xmlns="" id="{2DDA133B-C133-4783-91A5-E43DE20C9CE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4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6E44E824-6753-4098-8BD9-49E5404F7A44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1" y="6356352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128C83F-BF15-4054-BA85-497E3547C9AD}" type="datetimeFigureOut">
              <a:rPr lang="en-GB" smtClean="0"/>
              <a:t>27/05/2019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6FD05AC4-E536-4659-83DA-39A519D5EA21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4" y="6356352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54F14AC2-5D8F-4DFB-A98A-E01CF3AA19F1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1" y="6356352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495A5AF-13D4-49FB-BD28-1E6CFDBBF3D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0740969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5" name="Table 14">
            <a:extLst>
              <a:ext uri="{FF2B5EF4-FFF2-40B4-BE49-F238E27FC236}">
                <a16:creationId xmlns:a16="http://schemas.microsoft.com/office/drawing/2014/main" xmlns="" id="{948C9FD1-1BAF-47F4-8B7A-587A7F003B70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55006210"/>
              </p:ext>
            </p:extLst>
          </p:nvPr>
        </p:nvGraphicFramePr>
        <p:xfrm>
          <a:off x="496212" y="1151808"/>
          <a:ext cx="4952545" cy="3920842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1673099">
                  <a:extLst>
                    <a:ext uri="{9D8B030D-6E8A-4147-A177-3AD203B41FA5}">
                      <a16:colId xmlns:a16="http://schemas.microsoft.com/office/drawing/2014/main" xmlns="" val="989099909"/>
                    </a:ext>
                  </a:extLst>
                </a:gridCol>
                <a:gridCol w="1626577"/>
                <a:gridCol w="1652869"/>
              </a:tblGrid>
              <a:tr h="399232">
                <a:tc>
                  <a:txBody>
                    <a:bodyPr/>
                    <a:lstStyle/>
                    <a:p>
                      <a:r>
                        <a:rPr lang="en-GB" sz="1200" b="1" dirty="0"/>
                        <a:t>Bile acids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200" b="1" dirty="0"/>
                        <a:t>Detected m/z [M-H]</a:t>
                      </a:r>
                      <a:r>
                        <a:rPr lang="en-GB" sz="1200" b="1" baseline="30000" dirty="0"/>
                        <a:t>-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200" b="1" dirty="0"/>
                        <a:t>Retention Time (min)</a:t>
                      </a:r>
                      <a:endParaRPr lang="en-GB" sz="1200" b="1" baseline="300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907960436"/>
                  </a:ext>
                </a:extLst>
              </a:tr>
              <a:tr h="269992">
                <a:tc gridSpan="3">
                  <a:txBody>
                    <a:bodyPr/>
                    <a:lstStyle/>
                    <a:p>
                      <a:r>
                        <a:rPr lang="en-GB" sz="1200" i="1" dirty="0"/>
                        <a:t>Taurine conjugated</a:t>
                      </a:r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2874637213"/>
                  </a:ext>
                </a:extLst>
              </a:tr>
              <a:tr h="414201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200" dirty="0">
                          <a:latin typeface="Symbol" panose="05050102010706020507" pitchFamily="18" charset="2"/>
                        </a:rPr>
                        <a:t>a</a:t>
                      </a:r>
                      <a:r>
                        <a:rPr lang="en-GB" sz="1200" dirty="0"/>
                        <a:t>-</a:t>
                      </a:r>
                      <a:r>
                        <a:rPr lang="en-GB" sz="1200" dirty="0" err="1"/>
                        <a:t>tauromuricholic</a:t>
                      </a:r>
                      <a:r>
                        <a:rPr lang="en-GB" sz="1200" dirty="0"/>
                        <a:t> </a:t>
                      </a:r>
                      <a:r>
                        <a:rPr lang="en-GB" sz="1200" dirty="0" err="1"/>
                        <a:t>acid</a:t>
                      </a:r>
                      <a:r>
                        <a:rPr lang="en-GB" sz="1200" baseline="30000" dirty="0" err="1"/>
                        <a:t>a</a:t>
                      </a:r>
                      <a:endParaRPr lang="en-GB" sz="1200" baseline="300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dirty="0" smtClean="0"/>
                        <a:t>514.285</a:t>
                      </a:r>
                      <a:endParaRPr lang="en-GB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dirty="0"/>
                        <a:t>3.64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1959553101"/>
                  </a:ext>
                </a:extLst>
              </a:tr>
              <a:tr h="414201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200" dirty="0">
                          <a:latin typeface="Symbol" panose="05050102010706020507" pitchFamily="18" charset="2"/>
                        </a:rPr>
                        <a:t>b</a:t>
                      </a:r>
                      <a:r>
                        <a:rPr lang="en-GB" sz="1200" dirty="0"/>
                        <a:t>-</a:t>
                      </a:r>
                      <a:r>
                        <a:rPr lang="en-GB" sz="1200" dirty="0" err="1"/>
                        <a:t>tauromuricholic</a:t>
                      </a:r>
                      <a:r>
                        <a:rPr lang="en-GB" sz="1200" dirty="0"/>
                        <a:t> </a:t>
                      </a:r>
                      <a:r>
                        <a:rPr lang="en-GB" sz="1200" dirty="0" err="1"/>
                        <a:t>acid</a:t>
                      </a:r>
                      <a:r>
                        <a:rPr lang="en-GB" sz="1200" baseline="30000" dirty="0" err="1"/>
                        <a:t>a</a:t>
                      </a:r>
                      <a:endParaRPr lang="en-GB" sz="1200" baseline="300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200" dirty="0"/>
                        <a:t>514.285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200" dirty="0"/>
                        <a:t>3.72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924760793"/>
                  </a:ext>
                </a:extLst>
              </a:tr>
              <a:tr h="414201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200" dirty="0">
                          <a:latin typeface="Symbol" panose="05050102010706020507" pitchFamily="18" charset="2"/>
                        </a:rPr>
                        <a:t>w</a:t>
                      </a:r>
                      <a:r>
                        <a:rPr lang="en-GB" sz="1200" dirty="0"/>
                        <a:t>-</a:t>
                      </a:r>
                      <a:r>
                        <a:rPr lang="en-GB" sz="1200" dirty="0" err="1"/>
                        <a:t>tauromuricholic</a:t>
                      </a:r>
                      <a:r>
                        <a:rPr lang="en-GB" sz="1200" dirty="0"/>
                        <a:t> </a:t>
                      </a:r>
                      <a:r>
                        <a:rPr lang="en-GB" sz="1200" dirty="0" err="1"/>
                        <a:t>acid</a:t>
                      </a:r>
                      <a:r>
                        <a:rPr lang="en-GB" sz="1200" baseline="30000" dirty="0" err="1"/>
                        <a:t>a</a:t>
                      </a:r>
                      <a:endParaRPr lang="en-GB" sz="1200" baseline="300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200" dirty="0"/>
                        <a:t>514.285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200" dirty="0"/>
                        <a:t>3.53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1925906995"/>
                  </a:ext>
                </a:extLst>
              </a:tr>
              <a:tr h="158829">
                <a:tc>
                  <a:txBody>
                    <a:bodyPr/>
                    <a:lstStyle/>
                    <a:p>
                      <a:r>
                        <a:rPr lang="en-GB" sz="1200" dirty="0"/>
                        <a:t>taurocholic </a:t>
                      </a:r>
                      <a:r>
                        <a:rPr lang="en-GB" sz="1200" dirty="0" err="1"/>
                        <a:t>acid</a:t>
                      </a:r>
                      <a:r>
                        <a:rPr lang="en-GB" sz="1200" baseline="30000" dirty="0" err="1"/>
                        <a:t>b</a:t>
                      </a:r>
                      <a:endParaRPr lang="en-GB" sz="1200" baseline="300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200" dirty="0"/>
                        <a:t>514.285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dirty="0"/>
                        <a:t>4.43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210667793"/>
                  </a:ext>
                </a:extLst>
              </a:tr>
              <a:tr h="269992">
                <a:tc gridSpan="3">
                  <a:txBody>
                    <a:bodyPr/>
                    <a:lstStyle/>
                    <a:p>
                      <a:r>
                        <a:rPr lang="en-GB" sz="1200" i="1" dirty="0"/>
                        <a:t>Unconjugated</a:t>
                      </a:r>
                      <a:r>
                        <a:rPr lang="en-GB" sz="1200" dirty="0"/>
                        <a:t> </a:t>
                      </a:r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3070645658"/>
                  </a:ext>
                </a:extLst>
              </a:tr>
              <a:tr h="302469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200" dirty="0">
                          <a:latin typeface="Symbol" panose="05050102010706020507" pitchFamily="18" charset="2"/>
                        </a:rPr>
                        <a:t>a</a:t>
                      </a:r>
                      <a:r>
                        <a:rPr lang="en-GB" sz="1200" dirty="0"/>
                        <a:t>-muricholic </a:t>
                      </a:r>
                      <a:r>
                        <a:rPr lang="en-GB" sz="1200" dirty="0" err="1"/>
                        <a:t>acid</a:t>
                      </a:r>
                      <a:r>
                        <a:rPr lang="en-GB" sz="1200" baseline="30000" dirty="0" err="1"/>
                        <a:t>c</a:t>
                      </a:r>
                      <a:endParaRPr lang="en-GB" sz="1200" baseline="300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dirty="0"/>
                        <a:t>407.282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dirty="0"/>
                        <a:t>3.79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1564164110"/>
                  </a:ext>
                </a:extLst>
              </a:tr>
              <a:tr h="302469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200" dirty="0">
                          <a:latin typeface="Symbol" panose="05050102010706020507" pitchFamily="18" charset="2"/>
                        </a:rPr>
                        <a:t>b</a:t>
                      </a:r>
                      <a:r>
                        <a:rPr lang="en-GB" sz="1200" dirty="0"/>
                        <a:t>-muricholic </a:t>
                      </a:r>
                      <a:r>
                        <a:rPr lang="en-GB" sz="1200" dirty="0" err="1"/>
                        <a:t>acid</a:t>
                      </a:r>
                      <a:r>
                        <a:rPr lang="en-GB" sz="1200" baseline="30000" dirty="0" err="1"/>
                        <a:t>c</a:t>
                      </a:r>
                      <a:endParaRPr lang="en-GB" sz="1200" baseline="300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200" dirty="0"/>
                        <a:t>407.282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dirty="0"/>
                        <a:t>3.85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583140092"/>
                  </a:ext>
                </a:extLst>
              </a:tr>
              <a:tr h="302469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200" dirty="0">
                          <a:latin typeface="Symbol" panose="05050102010706020507" pitchFamily="18" charset="2"/>
                        </a:rPr>
                        <a:t>w</a:t>
                      </a:r>
                      <a:r>
                        <a:rPr lang="en-GB" sz="1200" dirty="0"/>
                        <a:t>-muricholic </a:t>
                      </a:r>
                      <a:r>
                        <a:rPr lang="en-GB" sz="1200" dirty="0" err="1"/>
                        <a:t>acid</a:t>
                      </a:r>
                      <a:r>
                        <a:rPr lang="en-GB" sz="1200" baseline="30000" dirty="0" err="1"/>
                        <a:t>c</a:t>
                      </a:r>
                      <a:endParaRPr lang="en-GB" sz="1200" baseline="300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200" dirty="0"/>
                        <a:t>407.282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dirty="0"/>
                        <a:t>4.01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3999918770"/>
                  </a:ext>
                </a:extLst>
              </a:tr>
              <a:tr h="269992">
                <a:tc>
                  <a:txBody>
                    <a:bodyPr/>
                    <a:lstStyle/>
                    <a:p>
                      <a:r>
                        <a:rPr lang="en-GB" sz="1200" dirty="0"/>
                        <a:t>cholic acid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200" dirty="0"/>
                        <a:t>407.279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dirty="0"/>
                        <a:t>4.45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1956486718"/>
                  </a:ext>
                </a:extLst>
              </a:tr>
              <a:tr h="269992">
                <a:tc>
                  <a:txBody>
                    <a:bodyPr/>
                    <a:lstStyle/>
                    <a:p>
                      <a:r>
                        <a:rPr lang="en-GB" sz="1200" dirty="0"/>
                        <a:t>deoxycholic </a:t>
                      </a:r>
                      <a:r>
                        <a:rPr lang="en-GB" sz="1200" dirty="0" err="1"/>
                        <a:t>acid</a:t>
                      </a:r>
                      <a:r>
                        <a:rPr lang="en-GB" sz="1200" baseline="30000" dirty="0" err="1"/>
                        <a:t>b</a:t>
                      </a:r>
                      <a:endParaRPr lang="en-GB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dirty="0"/>
                        <a:t>391.287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200" dirty="0"/>
                        <a:t>5.74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3701281491"/>
                  </a:ext>
                </a:extLst>
              </a:tr>
            </a:tbl>
          </a:graphicData>
        </a:graphic>
      </p:graphicFrame>
      <p:sp>
        <p:nvSpPr>
          <p:cNvPr id="16" name="TextBox 15">
            <a:extLst>
              <a:ext uri="{FF2B5EF4-FFF2-40B4-BE49-F238E27FC236}">
                <a16:creationId xmlns:a16="http://schemas.microsoft.com/office/drawing/2014/main" xmlns="" id="{FE543BBA-BAAE-4A52-A0E4-66210E27784C}"/>
              </a:ext>
            </a:extLst>
          </p:cNvPr>
          <p:cNvSpPr txBox="1"/>
          <p:nvPr/>
        </p:nvSpPr>
        <p:spPr>
          <a:xfrm>
            <a:off x="512433" y="646355"/>
            <a:ext cx="512241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 smtClean="0"/>
              <a:t>Figure S3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xmlns="" id="{5ECBA7D1-4409-4893-8017-3E307215D7CA}"/>
              </a:ext>
            </a:extLst>
          </p:cNvPr>
          <p:cNvSpPr txBox="1"/>
          <p:nvPr/>
        </p:nvSpPr>
        <p:spPr>
          <a:xfrm>
            <a:off x="833442" y="5355283"/>
            <a:ext cx="4632301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aseline="30000" dirty="0" err="1"/>
              <a:t>a,c</a:t>
            </a:r>
            <a:r>
              <a:rPr lang="en-GB" sz="1200" baseline="30000" dirty="0"/>
              <a:t> </a:t>
            </a:r>
            <a:r>
              <a:rPr lang="en-GB" sz="1200" dirty="0"/>
              <a:t>These are </a:t>
            </a:r>
            <a:r>
              <a:rPr lang="en-GB" sz="1200" dirty="0" err="1"/>
              <a:t>tauromuricholic</a:t>
            </a:r>
            <a:r>
              <a:rPr lang="en-GB" sz="1200" dirty="0"/>
              <a:t> acids or muricholic acids. The assignments of </a:t>
            </a:r>
            <a:r>
              <a:rPr lang="en-GB" sz="1200" dirty="0">
                <a:latin typeface="Symbol" panose="05050102010706020507" pitchFamily="18" charset="2"/>
              </a:rPr>
              <a:t>a</a:t>
            </a:r>
            <a:r>
              <a:rPr lang="en-GB" sz="1200" dirty="0"/>
              <a:t>-, </a:t>
            </a:r>
            <a:r>
              <a:rPr lang="en-GB" sz="1200" dirty="0">
                <a:latin typeface="Symbol" panose="05050102010706020507" pitchFamily="18" charset="2"/>
              </a:rPr>
              <a:t>b</a:t>
            </a:r>
            <a:r>
              <a:rPr lang="en-GB" sz="1200" dirty="0"/>
              <a:t>- and </a:t>
            </a:r>
            <a:r>
              <a:rPr lang="en-GB" sz="1200" dirty="0">
                <a:latin typeface="Symbol" panose="05050102010706020507" pitchFamily="18" charset="2"/>
              </a:rPr>
              <a:t>w</a:t>
            </a:r>
            <a:r>
              <a:rPr lang="en-GB" sz="1200" dirty="0"/>
              <a:t>- are based on the retention time from the in-house database.</a:t>
            </a:r>
          </a:p>
          <a:p>
            <a:r>
              <a:rPr lang="en-GB" sz="1200" baseline="30000" dirty="0"/>
              <a:t>b</a:t>
            </a:r>
            <a:r>
              <a:rPr lang="en-GB" sz="1200" dirty="0"/>
              <a:t> These bile acids are confirmed with the standard compounds. </a:t>
            </a:r>
          </a:p>
        </p:txBody>
      </p:sp>
      <p:pic>
        <p:nvPicPr>
          <p:cNvPr id="2053" name="Picture 5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956916" y="452763"/>
            <a:ext cx="5872918" cy="569058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64502104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0</TotalTime>
  <Words>92</Words>
  <Application>Microsoft Office PowerPoint</Application>
  <PresentationFormat>Custom</PresentationFormat>
  <Paragraphs>35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i, Jia</dc:creator>
  <cp:lastModifiedBy>gd51y</cp:lastModifiedBy>
  <cp:revision>8</cp:revision>
  <dcterms:created xsi:type="dcterms:W3CDTF">2019-04-24T18:29:23Z</dcterms:created>
  <dcterms:modified xsi:type="dcterms:W3CDTF">2019-05-27T13:24:55Z</dcterms:modified>
</cp:coreProperties>
</file>